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theme/themeOverride1.xml" ContentType="application/vnd.openxmlformats-officedocument.themeOverride+xml"/>
  <Override PartName="/ppt/charts/chart4.xml" ContentType="application/vnd.openxmlformats-officedocument.drawingml.chart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 varScale="1">
        <p:scale>
          <a:sx n="100" d="100"/>
          <a:sy n="100" d="100"/>
        </p:scale>
        <p:origin x="756" y="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1.bin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2.bin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KUBOTA\Desktop\&#22522;&#30990;&#23455;&#39443;\CyD\CyD%20(PLoS%20ONE)\Revise\Cell%20Cycle%20(revise).xlsx" TargetMode="External"/><Relationship Id="rId1" Type="http://schemas.openxmlformats.org/officeDocument/2006/relationships/themeOverride" Target="../theme/themeOverride1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KUBOTA\Desktop\&#22522;&#30990;&#23455;&#39443;\CyD\CyD%20(PLoS%20ONE)\Revise\Cell%20Cycle%20(revise).xlsx" TargetMode="External"/><Relationship Id="rId1" Type="http://schemas.openxmlformats.org/officeDocument/2006/relationships/themeOverride" Target="../theme/themeOverrid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dirty="0" smtClean="0"/>
              <a:t>KCL22/HA</a:t>
            </a:r>
            <a:endParaRPr lang="en-US" dirty="0"/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apoptosis FCMまとめ(2015-8-15).xlsx]K562HA'!$F$20</c:f>
              <c:strCache>
                <c:ptCount val="1"/>
                <c:pt idx="0">
                  <c:v>24hr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[apoptosis FCMまとめ(2015-8-15).xlsx]K562HA'!$C$11:$F$11</c:f>
                <c:numCache>
                  <c:formatCode>General</c:formatCode>
                  <c:ptCount val="4"/>
                  <c:pt idx="0">
                    <c:v>0.98816327935552339</c:v>
                  </c:pt>
                  <c:pt idx="1">
                    <c:v>0.95367126877603403</c:v>
                  </c:pt>
                  <c:pt idx="2">
                    <c:v>1.6853090715553245</c:v>
                  </c:pt>
                  <c:pt idx="3">
                    <c:v>0.90579615072413888</c:v>
                  </c:pt>
                </c:numCache>
              </c:numRef>
            </c:plus>
            <c:minus>
              <c:numRef>
                <c:f>'[apoptosis FCMまとめ(2015-8-15).xlsx]K562HA'!$C$11:$F$11</c:f>
                <c:numCache>
                  <c:formatCode>General</c:formatCode>
                  <c:ptCount val="4"/>
                  <c:pt idx="0">
                    <c:v>0.98816327935552339</c:v>
                  </c:pt>
                  <c:pt idx="1">
                    <c:v>0.95367126877603403</c:v>
                  </c:pt>
                  <c:pt idx="2">
                    <c:v>1.6853090715553245</c:v>
                  </c:pt>
                  <c:pt idx="3">
                    <c:v>0.90579615072413888</c:v>
                  </c:pt>
                </c:numCache>
              </c:numRef>
            </c:minus>
          </c:errBars>
          <c:cat>
            <c:numRef>
              <c:f>'[apoptosis FCMまとめ(2015-8-15).xlsx]K562HA'!$G$19:$J$19</c:f>
              <c:numCache>
                <c:formatCode>General</c:formatCode>
                <c:ptCount val="4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</c:numCache>
            </c:numRef>
          </c:cat>
          <c:val>
            <c:numRef>
              <c:f>'[apoptosis FCMまとめ(2015-8-15).xlsx]K562HA'!$G$20:$J$20</c:f>
              <c:numCache>
                <c:formatCode>General</c:formatCode>
                <c:ptCount val="4"/>
                <c:pt idx="0">
                  <c:v>7.9899999999999993</c:v>
                </c:pt>
                <c:pt idx="1">
                  <c:v>7.3633333333333333</c:v>
                </c:pt>
                <c:pt idx="2">
                  <c:v>10.950000000000001</c:v>
                </c:pt>
                <c:pt idx="3">
                  <c:v>26.7000000000000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41330120"/>
        <c:axId val="241330512"/>
      </c:barChart>
      <c:catAx>
        <c:axId val="2413301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200" b="1" baseline="0"/>
            </a:pPr>
            <a:endParaRPr lang="ja-JP"/>
          </a:p>
        </c:txPr>
        <c:crossAx val="241330512"/>
        <c:crosses val="autoZero"/>
        <c:auto val="1"/>
        <c:lblAlgn val="ctr"/>
        <c:lblOffset val="100"/>
        <c:noMultiLvlLbl val="0"/>
      </c:catAx>
      <c:valAx>
        <c:axId val="24133051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400"/>
                </a:pPr>
                <a:r>
                  <a:rPr lang="en-US" sz="1400"/>
                  <a:t>Annexin V+ (%)</a:t>
                </a:r>
                <a:endParaRPr lang="ja-JP" sz="140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241330120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dirty="0" smtClean="0"/>
              <a:t>K562/HA</a:t>
            </a:r>
            <a:endParaRPr lang="en-US" dirty="0"/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apoptosis FCMまとめ(2015-8-15).xlsx]KCL22HA'!$F$22</c:f>
              <c:strCache>
                <c:ptCount val="1"/>
                <c:pt idx="0">
                  <c:v>24hr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[apoptosis FCMまとめ(2015-8-15).xlsx]KCL22HA'!$C$12:$F$12</c:f>
                <c:numCache>
                  <c:formatCode>General</c:formatCode>
                  <c:ptCount val="4"/>
                  <c:pt idx="0">
                    <c:v>0.31351058816073329</c:v>
                  </c:pt>
                  <c:pt idx="1">
                    <c:v>0.75495400890091025</c:v>
                  </c:pt>
                  <c:pt idx="2">
                    <c:v>1.1881170911245331</c:v>
                  </c:pt>
                  <c:pt idx="3">
                    <c:v>4.2481368465089062</c:v>
                  </c:pt>
                </c:numCache>
              </c:numRef>
            </c:plus>
            <c:minus>
              <c:numRef>
                <c:f>'[apoptosis FCMまとめ(2015-8-15).xlsx]KCL22HA'!$C$12:$F$12</c:f>
                <c:numCache>
                  <c:formatCode>General</c:formatCode>
                  <c:ptCount val="4"/>
                  <c:pt idx="0">
                    <c:v>0.31351058816073329</c:v>
                  </c:pt>
                  <c:pt idx="1">
                    <c:v>0.75495400890091025</c:v>
                  </c:pt>
                  <c:pt idx="2">
                    <c:v>1.1881170911245331</c:v>
                  </c:pt>
                  <c:pt idx="3">
                    <c:v>4.2481368465089062</c:v>
                  </c:pt>
                </c:numCache>
              </c:numRef>
            </c:minus>
          </c:errBars>
          <c:cat>
            <c:numRef>
              <c:f>'[apoptosis FCMまとめ(2015-8-15).xlsx]KCL22HA'!$G$21:$J$21</c:f>
              <c:numCache>
                <c:formatCode>General</c:formatCode>
                <c:ptCount val="4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</c:numCache>
            </c:numRef>
          </c:cat>
          <c:val>
            <c:numRef>
              <c:f>'[apoptosis FCMまとめ(2015-8-15).xlsx]KCL22HA'!$G$22:$J$22</c:f>
              <c:numCache>
                <c:formatCode>General</c:formatCode>
                <c:ptCount val="4"/>
                <c:pt idx="0">
                  <c:v>9.7733333333333334</c:v>
                </c:pt>
                <c:pt idx="1">
                  <c:v>10.076666666666666</c:v>
                </c:pt>
                <c:pt idx="2">
                  <c:v>20.09333333333333</c:v>
                </c:pt>
                <c:pt idx="3">
                  <c:v>57.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87018792"/>
        <c:axId val="287019184"/>
      </c:barChart>
      <c:catAx>
        <c:axId val="2870187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287019184"/>
        <c:crosses val="autoZero"/>
        <c:auto val="1"/>
        <c:lblAlgn val="ctr"/>
        <c:lblOffset val="100"/>
        <c:noMultiLvlLbl val="0"/>
      </c:catAx>
      <c:valAx>
        <c:axId val="287019184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400"/>
                </a:pPr>
                <a:r>
                  <a:rPr lang="en-US" sz="1400"/>
                  <a:t>Annexin V + (%)</a:t>
                </a:r>
                <a:endParaRPr lang="ja-JP" sz="140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287018792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KCL22/HA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K562HA!$I$2</c:f>
              <c:strCache>
                <c:ptCount val="1"/>
                <c:pt idx="0">
                  <c:v>G1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K562HA!$J$8:$L$8</c:f>
                <c:numCache>
                  <c:formatCode>General</c:formatCode>
                  <c:ptCount val="3"/>
                  <c:pt idx="0">
                    <c:v>2.2368132093076789</c:v>
                  </c:pt>
                  <c:pt idx="1">
                    <c:v>5.9396969619670035</c:v>
                  </c:pt>
                  <c:pt idx="2">
                    <c:v>1.7320508075688772</c:v>
                  </c:pt>
                </c:numCache>
              </c:numRef>
            </c:plus>
            <c:minus>
              <c:numRef>
                <c:f>K562HA!$J$8:$L$8</c:f>
                <c:numCache>
                  <c:formatCode>General</c:formatCode>
                  <c:ptCount val="3"/>
                  <c:pt idx="0">
                    <c:v>2.2368132093076789</c:v>
                  </c:pt>
                  <c:pt idx="1">
                    <c:v>5.9396969619670035</c:v>
                  </c:pt>
                  <c:pt idx="2">
                    <c:v>1.7320508075688772</c:v>
                  </c:pt>
                </c:numCache>
              </c:numRef>
            </c:minus>
          </c:errBars>
          <c:cat>
            <c:numRef>
              <c:f>K562HA!$J$1:$L$1</c:f>
              <c:numCache>
                <c:formatCode>General</c:formatCode>
                <c:ptCount val="3"/>
                <c:pt idx="0">
                  <c:v>0</c:v>
                </c:pt>
                <c:pt idx="1">
                  <c:v>7.5</c:v>
                </c:pt>
                <c:pt idx="2">
                  <c:v>15</c:v>
                </c:pt>
              </c:numCache>
            </c:numRef>
          </c:cat>
          <c:val>
            <c:numRef>
              <c:f>K562HA!$J$2:$L$2</c:f>
              <c:numCache>
                <c:formatCode>General</c:formatCode>
                <c:ptCount val="3"/>
                <c:pt idx="0">
                  <c:v>58.733333333333327</c:v>
                </c:pt>
                <c:pt idx="1">
                  <c:v>57.066666666666663</c:v>
                </c:pt>
                <c:pt idx="2">
                  <c:v>35.700000000000003</c:v>
                </c:pt>
              </c:numCache>
            </c:numRef>
          </c:val>
        </c:ser>
        <c:ser>
          <c:idx val="1"/>
          <c:order val="1"/>
          <c:tx>
            <c:strRef>
              <c:f>K562HA!$I$3</c:f>
              <c:strCache>
                <c:ptCount val="1"/>
                <c:pt idx="0">
                  <c:v>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K562HA!$J$9:$L$9</c:f>
                <c:numCache>
                  <c:formatCode>General</c:formatCode>
                  <c:ptCount val="3"/>
                  <c:pt idx="0">
                    <c:v>1.4177446878757818</c:v>
                  </c:pt>
                  <c:pt idx="1">
                    <c:v>3.8630730427126654</c:v>
                  </c:pt>
                  <c:pt idx="2">
                    <c:v>0.56862407030773343</c:v>
                  </c:pt>
                </c:numCache>
              </c:numRef>
            </c:plus>
            <c:minus>
              <c:numRef>
                <c:f>K562HA!$J$9:$L$9</c:f>
                <c:numCache>
                  <c:formatCode>General</c:formatCode>
                  <c:ptCount val="3"/>
                  <c:pt idx="0">
                    <c:v>1.4177446878757818</c:v>
                  </c:pt>
                  <c:pt idx="1">
                    <c:v>3.8630730427126654</c:v>
                  </c:pt>
                  <c:pt idx="2">
                    <c:v>0.56862407030773343</c:v>
                  </c:pt>
                </c:numCache>
              </c:numRef>
            </c:minus>
          </c:errBars>
          <c:cat>
            <c:numRef>
              <c:f>K562HA!$J$1:$L$1</c:f>
              <c:numCache>
                <c:formatCode>General</c:formatCode>
                <c:ptCount val="3"/>
                <c:pt idx="0">
                  <c:v>0</c:v>
                </c:pt>
                <c:pt idx="1">
                  <c:v>7.5</c:v>
                </c:pt>
                <c:pt idx="2">
                  <c:v>15</c:v>
                </c:pt>
              </c:numCache>
            </c:numRef>
          </c:cat>
          <c:val>
            <c:numRef>
              <c:f>K562HA!$J$3:$L$3</c:f>
              <c:numCache>
                <c:formatCode>General</c:formatCode>
                <c:ptCount val="3"/>
                <c:pt idx="0">
                  <c:v>20.7</c:v>
                </c:pt>
                <c:pt idx="1">
                  <c:v>21.333333333333332</c:v>
                </c:pt>
                <c:pt idx="2">
                  <c:v>20.95</c:v>
                </c:pt>
              </c:numCache>
            </c:numRef>
          </c:val>
        </c:ser>
        <c:ser>
          <c:idx val="2"/>
          <c:order val="2"/>
          <c:tx>
            <c:strRef>
              <c:f>K562HA!$I$4</c:f>
              <c:strCache>
                <c:ptCount val="1"/>
                <c:pt idx="0">
                  <c:v>G2/M</c:v>
                </c:pt>
              </c:strCache>
            </c:strRef>
          </c:tx>
          <c:spPr>
            <a:solidFill>
              <a:schemeClr val="tx1"/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K562HA!$J$10:$L$10</c:f>
                <c:numCache>
                  <c:formatCode>General</c:formatCode>
                  <c:ptCount val="3"/>
                  <c:pt idx="0">
                    <c:v>0.40000000000000036</c:v>
                  </c:pt>
                  <c:pt idx="1">
                    <c:v>1.1930353445448849</c:v>
                  </c:pt>
                  <c:pt idx="2">
                    <c:v>2.1939310229205797</c:v>
                  </c:pt>
                </c:numCache>
              </c:numRef>
            </c:plus>
            <c:minus>
              <c:numRef>
                <c:f>K562HA!$J$10:$L$10</c:f>
                <c:numCache>
                  <c:formatCode>General</c:formatCode>
                  <c:ptCount val="3"/>
                  <c:pt idx="0">
                    <c:v>0.40000000000000036</c:v>
                  </c:pt>
                  <c:pt idx="1">
                    <c:v>1.1930353445448849</c:v>
                  </c:pt>
                  <c:pt idx="2">
                    <c:v>2.1939310229205797</c:v>
                  </c:pt>
                </c:numCache>
              </c:numRef>
            </c:minus>
          </c:errBars>
          <c:cat>
            <c:numRef>
              <c:f>K562HA!$J$1:$L$1</c:f>
              <c:numCache>
                <c:formatCode>General</c:formatCode>
                <c:ptCount val="3"/>
                <c:pt idx="0">
                  <c:v>0</c:v>
                </c:pt>
                <c:pt idx="1">
                  <c:v>7.5</c:v>
                </c:pt>
                <c:pt idx="2">
                  <c:v>15</c:v>
                </c:pt>
              </c:numCache>
            </c:numRef>
          </c:cat>
          <c:val>
            <c:numRef>
              <c:f>K562HA!$J$4:$L$4</c:f>
              <c:numCache>
                <c:formatCode>General</c:formatCode>
                <c:ptCount val="3"/>
                <c:pt idx="0">
                  <c:v>12.1</c:v>
                </c:pt>
                <c:pt idx="1">
                  <c:v>11.833333333333334</c:v>
                </c:pt>
                <c:pt idx="2">
                  <c:v>27.63333333333333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87019968"/>
        <c:axId val="287020360"/>
      </c:barChart>
      <c:catAx>
        <c:axId val="2870199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287020360"/>
        <c:crosses val="autoZero"/>
        <c:auto val="1"/>
        <c:lblAlgn val="ctr"/>
        <c:lblOffset val="100"/>
        <c:noMultiLvlLbl val="0"/>
      </c:catAx>
      <c:valAx>
        <c:axId val="28702036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28701996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80340419947506558"/>
          <c:y val="0.23779235928842227"/>
          <c:w val="0.11326246719160105"/>
          <c:h val="0.25115157480314959"/>
        </c:manualLayout>
      </c:layout>
      <c:overlay val="0"/>
      <c:txPr>
        <a:bodyPr/>
        <a:lstStyle/>
        <a:p>
          <a:pPr>
            <a:defRPr sz="1100">
              <a:latin typeface="Arial" panose="020B0604020202020204" pitchFamily="34" charset="0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 w="25400">
      <a:noFill/>
    </a:ln>
  </c:sp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K562/HA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KCL22HA!$I$2</c:f>
              <c:strCache>
                <c:ptCount val="1"/>
                <c:pt idx="0">
                  <c:v>G1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KCL22HA!$J$7:$L$7</c:f>
                <c:numCache>
                  <c:formatCode>General</c:formatCode>
                  <c:ptCount val="3"/>
                  <c:pt idx="0">
                    <c:v>3.0038863715748865</c:v>
                  </c:pt>
                  <c:pt idx="1">
                    <c:v>2.8041635710730817</c:v>
                  </c:pt>
                  <c:pt idx="2">
                    <c:v>1.2503332889007368</c:v>
                  </c:pt>
                </c:numCache>
              </c:numRef>
            </c:plus>
            <c:minus>
              <c:numRef>
                <c:f>KCL22HA!$J$7:$L$7</c:f>
                <c:numCache>
                  <c:formatCode>General</c:formatCode>
                  <c:ptCount val="3"/>
                  <c:pt idx="0">
                    <c:v>3.0038863715748865</c:v>
                  </c:pt>
                  <c:pt idx="1">
                    <c:v>2.8041635710730817</c:v>
                  </c:pt>
                  <c:pt idx="2">
                    <c:v>1.2503332889007368</c:v>
                  </c:pt>
                </c:numCache>
              </c:numRef>
            </c:minus>
          </c:errBars>
          <c:cat>
            <c:numRef>
              <c:f>KCL22HA!$J$1:$L$1</c:f>
              <c:numCache>
                <c:formatCode>General</c:formatCode>
                <c:ptCount val="3"/>
                <c:pt idx="0">
                  <c:v>0</c:v>
                </c:pt>
                <c:pt idx="1">
                  <c:v>5</c:v>
                </c:pt>
                <c:pt idx="2">
                  <c:v>7.5</c:v>
                </c:pt>
              </c:numCache>
            </c:numRef>
          </c:cat>
          <c:val>
            <c:numRef>
              <c:f>KCL22HA!$J$2:$L$2</c:f>
              <c:numCache>
                <c:formatCode>General</c:formatCode>
                <c:ptCount val="3"/>
                <c:pt idx="0">
                  <c:v>26.866666666666664</c:v>
                </c:pt>
                <c:pt idx="1">
                  <c:v>26.633333333333336</c:v>
                </c:pt>
                <c:pt idx="2">
                  <c:v>19.666666666666668</c:v>
                </c:pt>
              </c:numCache>
            </c:numRef>
          </c:val>
        </c:ser>
        <c:ser>
          <c:idx val="1"/>
          <c:order val="1"/>
          <c:tx>
            <c:strRef>
              <c:f>KCL22HA!$I$3</c:f>
              <c:strCache>
                <c:ptCount val="1"/>
                <c:pt idx="0">
                  <c:v>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KCL22HA!$J$8:$L$8</c:f>
                <c:numCache>
                  <c:formatCode>General</c:formatCode>
                  <c:ptCount val="3"/>
                  <c:pt idx="0">
                    <c:v>1.5044378795195688</c:v>
                  </c:pt>
                  <c:pt idx="1">
                    <c:v>3.0005555041247494</c:v>
                  </c:pt>
                  <c:pt idx="2">
                    <c:v>1.2013880860626744</c:v>
                  </c:pt>
                </c:numCache>
              </c:numRef>
            </c:plus>
            <c:minus>
              <c:numRef>
                <c:f>KCL22HA!$J$8:$L$8</c:f>
                <c:numCache>
                  <c:formatCode>General</c:formatCode>
                  <c:ptCount val="3"/>
                  <c:pt idx="0">
                    <c:v>1.5044378795195688</c:v>
                  </c:pt>
                  <c:pt idx="1">
                    <c:v>3.0005555041247494</c:v>
                  </c:pt>
                  <c:pt idx="2">
                    <c:v>1.2013880860626744</c:v>
                  </c:pt>
                </c:numCache>
              </c:numRef>
            </c:minus>
          </c:errBars>
          <c:cat>
            <c:numRef>
              <c:f>KCL22HA!$J$1:$L$1</c:f>
              <c:numCache>
                <c:formatCode>General</c:formatCode>
                <c:ptCount val="3"/>
                <c:pt idx="0">
                  <c:v>0</c:v>
                </c:pt>
                <c:pt idx="1">
                  <c:v>5</c:v>
                </c:pt>
                <c:pt idx="2">
                  <c:v>7.5</c:v>
                </c:pt>
              </c:numCache>
            </c:numRef>
          </c:cat>
          <c:val>
            <c:numRef>
              <c:f>KCL22HA!$J$3:$L$3</c:f>
              <c:numCache>
                <c:formatCode>General</c:formatCode>
                <c:ptCount val="3"/>
                <c:pt idx="0">
                  <c:v>31.366666666666664</c:v>
                </c:pt>
                <c:pt idx="1">
                  <c:v>30.733333333333334</c:v>
                </c:pt>
                <c:pt idx="2">
                  <c:v>32.93333333333333</c:v>
                </c:pt>
              </c:numCache>
            </c:numRef>
          </c:val>
        </c:ser>
        <c:ser>
          <c:idx val="2"/>
          <c:order val="2"/>
          <c:tx>
            <c:strRef>
              <c:f>KCL22HA!$I$4</c:f>
              <c:strCache>
                <c:ptCount val="1"/>
                <c:pt idx="0">
                  <c:v>G2/M</c:v>
                </c:pt>
              </c:strCache>
            </c:strRef>
          </c:tx>
          <c:spPr>
            <a:solidFill>
              <a:schemeClr val="tx1"/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KCL22HA!$J$9:$L$9</c:f>
                <c:numCache>
                  <c:formatCode>General</c:formatCode>
                  <c:ptCount val="3"/>
                  <c:pt idx="0">
                    <c:v>3.0049958402633434</c:v>
                  </c:pt>
                  <c:pt idx="1">
                    <c:v>2.705549851693736</c:v>
                  </c:pt>
                  <c:pt idx="2">
                    <c:v>0.51316014394468878</c:v>
                  </c:pt>
                </c:numCache>
              </c:numRef>
            </c:plus>
            <c:minus>
              <c:numRef>
                <c:f>KCL22HA!$J$9:$L$9</c:f>
                <c:numCache>
                  <c:formatCode>General</c:formatCode>
                  <c:ptCount val="3"/>
                  <c:pt idx="0">
                    <c:v>3.0049958402633434</c:v>
                  </c:pt>
                  <c:pt idx="1">
                    <c:v>2.705549851693736</c:v>
                  </c:pt>
                  <c:pt idx="2">
                    <c:v>0.51316014394468878</c:v>
                  </c:pt>
                </c:numCache>
              </c:numRef>
            </c:minus>
          </c:errBars>
          <c:cat>
            <c:numRef>
              <c:f>KCL22HA!$J$1:$L$1</c:f>
              <c:numCache>
                <c:formatCode>General</c:formatCode>
                <c:ptCount val="3"/>
                <c:pt idx="0">
                  <c:v>0</c:v>
                </c:pt>
                <c:pt idx="1">
                  <c:v>5</c:v>
                </c:pt>
                <c:pt idx="2">
                  <c:v>7.5</c:v>
                </c:pt>
              </c:numCache>
            </c:numRef>
          </c:cat>
          <c:val>
            <c:numRef>
              <c:f>KCL22HA!$J$4:$L$4</c:f>
              <c:numCache>
                <c:formatCode>General</c:formatCode>
                <c:ptCount val="3"/>
                <c:pt idx="0">
                  <c:v>24.900000000000002</c:v>
                </c:pt>
                <c:pt idx="1">
                  <c:v>28.900000000000002</c:v>
                </c:pt>
                <c:pt idx="2">
                  <c:v>34.5666666666666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87021144"/>
        <c:axId val="287021536"/>
      </c:barChart>
      <c:catAx>
        <c:axId val="2870211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287021536"/>
        <c:crosses val="autoZero"/>
        <c:auto val="1"/>
        <c:lblAlgn val="ctr"/>
        <c:lblOffset val="100"/>
        <c:noMultiLvlLbl val="0"/>
      </c:catAx>
      <c:valAx>
        <c:axId val="287021536"/>
        <c:scaling>
          <c:orientation val="minMax"/>
          <c:max val="5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287021144"/>
        <c:crosses val="autoZero"/>
        <c:crossBetween val="between"/>
        <c:majorUnit val="10"/>
      </c:valAx>
    </c:plotArea>
    <c:legend>
      <c:legendPos val="r"/>
      <c:layout>
        <c:manualLayout>
          <c:xMode val="edge"/>
          <c:yMode val="edge"/>
          <c:x val="0.83673753280839891"/>
          <c:y val="0.22853310002916302"/>
          <c:w val="0.11326246719160105"/>
          <c:h val="0.25115157480314959"/>
        </c:manualLayout>
      </c:layout>
      <c:overlay val="0"/>
      <c:txPr>
        <a:bodyPr/>
        <a:lstStyle/>
        <a:p>
          <a:pPr>
            <a:defRPr sz="1100">
              <a:latin typeface="Arial" panose="020B0604020202020204" pitchFamily="34" charset="0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</c:sp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AFF14-668F-4D98-AE82-347249780D82}" type="datetimeFigureOut">
              <a:rPr kumimoji="1" lang="ja-JP" altLang="en-US" smtClean="0"/>
              <a:t>2015/9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46CE43-D567-42D0-BD63-2BF58087CB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92754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AFF14-668F-4D98-AE82-347249780D82}" type="datetimeFigureOut">
              <a:rPr kumimoji="1" lang="ja-JP" altLang="en-US" smtClean="0"/>
              <a:t>2015/9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46CE43-D567-42D0-BD63-2BF58087CB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55651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AFF14-668F-4D98-AE82-347249780D82}" type="datetimeFigureOut">
              <a:rPr kumimoji="1" lang="ja-JP" altLang="en-US" smtClean="0"/>
              <a:t>2015/9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46CE43-D567-42D0-BD63-2BF58087CB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10780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AFF14-668F-4D98-AE82-347249780D82}" type="datetimeFigureOut">
              <a:rPr kumimoji="1" lang="ja-JP" altLang="en-US" smtClean="0"/>
              <a:t>2015/9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46CE43-D567-42D0-BD63-2BF58087CB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58284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AFF14-668F-4D98-AE82-347249780D82}" type="datetimeFigureOut">
              <a:rPr kumimoji="1" lang="ja-JP" altLang="en-US" smtClean="0"/>
              <a:t>2015/9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46CE43-D567-42D0-BD63-2BF58087CB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34201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AFF14-668F-4D98-AE82-347249780D82}" type="datetimeFigureOut">
              <a:rPr kumimoji="1" lang="ja-JP" altLang="en-US" smtClean="0"/>
              <a:t>2015/9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46CE43-D567-42D0-BD63-2BF58087CB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87036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AFF14-668F-4D98-AE82-347249780D82}" type="datetimeFigureOut">
              <a:rPr kumimoji="1" lang="ja-JP" altLang="en-US" smtClean="0"/>
              <a:t>2015/9/1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46CE43-D567-42D0-BD63-2BF58087CB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38141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AFF14-668F-4D98-AE82-347249780D82}" type="datetimeFigureOut">
              <a:rPr kumimoji="1" lang="ja-JP" altLang="en-US" smtClean="0"/>
              <a:t>2015/9/1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46CE43-D567-42D0-BD63-2BF58087CB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87625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AFF14-668F-4D98-AE82-347249780D82}" type="datetimeFigureOut">
              <a:rPr kumimoji="1" lang="ja-JP" altLang="en-US" smtClean="0"/>
              <a:t>2015/9/1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46CE43-D567-42D0-BD63-2BF58087CB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13764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AFF14-668F-4D98-AE82-347249780D82}" type="datetimeFigureOut">
              <a:rPr kumimoji="1" lang="ja-JP" altLang="en-US" smtClean="0"/>
              <a:t>2015/9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46CE43-D567-42D0-BD63-2BF58087CB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01299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AFF14-668F-4D98-AE82-347249780D82}" type="datetimeFigureOut">
              <a:rPr kumimoji="1" lang="ja-JP" altLang="en-US" smtClean="0"/>
              <a:t>2015/9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46CE43-D567-42D0-BD63-2BF58087CB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68702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9AFF14-668F-4D98-AE82-347249780D82}" type="datetimeFigureOut">
              <a:rPr kumimoji="1" lang="ja-JP" altLang="en-US" smtClean="0"/>
              <a:t>2015/9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46CE43-D567-42D0-BD63-2BF58087CB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42863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59249214"/>
              </p:ext>
            </p:extLst>
          </p:nvPr>
        </p:nvGraphicFramePr>
        <p:xfrm>
          <a:off x="144016" y="18864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グラフ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02031960"/>
              </p:ext>
            </p:extLst>
          </p:nvPr>
        </p:nvGraphicFramePr>
        <p:xfrm>
          <a:off x="4572000" y="18864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テキスト ボックス 3"/>
          <p:cNvSpPr txBox="1"/>
          <p:nvPr/>
        </p:nvSpPr>
        <p:spPr>
          <a:xfrm>
            <a:off x="179512" y="44624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4716016" y="44624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直線コネクタ 6"/>
          <p:cNvCxnSpPr/>
          <p:nvPr/>
        </p:nvCxnSpPr>
        <p:spPr>
          <a:xfrm>
            <a:off x="899592" y="2996952"/>
            <a:ext cx="799288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テキスト ボックス 7"/>
          <p:cNvSpPr txBox="1"/>
          <p:nvPr/>
        </p:nvSpPr>
        <p:spPr>
          <a:xfrm>
            <a:off x="3851920" y="3068960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HP-</a:t>
            </a:r>
            <a:r>
              <a:rPr kumimoji="1" lang="el-GR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1"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en-US" altLang="ja-JP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yD</a:t>
            </a:r>
            <a:r>
              <a:rPr kumimoji="1"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kumimoji="1" lang="en-US" altLang="ja-JP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kumimoji="1"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9" name="グラフ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01328553"/>
              </p:ext>
            </p:extLst>
          </p:nvPr>
        </p:nvGraphicFramePr>
        <p:xfrm>
          <a:off x="293975" y="3573016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0" name="グラフ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38895195"/>
              </p:ext>
            </p:extLst>
          </p:nvPr>
        </p:nvGraphicFramePr>
        <p:xfrm>
          <a:off x="4694237" y="3587624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cxnSp>
        <p:nvCxnSpPr>
          <p:cNvPr id="11" name="直線コネクタ 10"/>
          <p:cNvCxnSpPr/>
          <p:nvPr/>
        </p:nvCxnSpPr>
        <p:spPr>
          <a:xfrm>
            <a:off x="683568" y="6381328"/>
            <a:ext cx="799288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テキスト ボックス 11"/>
          <p:cNvSpPr txBox="1"/>
          <p:nvPr/>
        </p:nvSpPr>
        <p:spPr>
          <a:xfrm>
            <a:off x="3779912" y="6444044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HP-</a:t>
            </a:r>
            <a:r>
              <a:rPr kumimoji="1" lang="el-GR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1"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en-US" altLang="ja-JP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yD</a:t>
            </a:r>
            <a:r>
              <a:rPr kumimoji="1"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kumimoji="1" lang="en-US" altLang="ja-JP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kumimoji="1"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251520" y="3563724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4716016" y="3573016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3851920" y="413956"/>
            <a:ext cx="5040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＊＊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8316416" y="404664"/>
            <a:ext cx="5040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＊＊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7380312" y="1567825"/>
            <a:ext cx="5040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＊＊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937707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28</TotalTime>
  <Words>34</Words>
  <Application>Microsoft Office PowerPoint</Application>
  <PresentationFormat>画面に合わせる (4:3)</PresentationFormat>
  <Paragraphs>1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ASUSHI KUBOTA</dc:creator>
  <cp:lastModifiedBy>久保田　寧</cp:lastModifiedBy>
  <cp:revision>7</cp:revision>
  <dcterms:created xsi:type="dcterms:W3CDTF">2015-08-16T07:08:11Z</dcterms:created>
  <dcterms:modified xsi:type="dcterms:W3CDTF">2015-09-15T05:49:44Z</dcterms:modified>
</cp:coreProperties>
</file>